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D309F-9F97-4801-8926-5B1C9C5DD3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0E61A5-B551-4BF1-B663-D25BF91786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47653-EDC5-4C72-BD91-48995DE651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3A79D-A033-4C96-9615-1BD9B98250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F3C27-7366-459D-8818-C062675B0C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73065-7666-467B-9C72-AD36685982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DEE88-507A-40F2-B8D4-46F09653AF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583DA-F9B9-476F-8ACD-D307ACF8E5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C68B4-E450-4AF6-8946-B15F69D0B2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E34F4-48F8-4695-8AD7-2B80035CAC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538D0-B642-4C1D-BEC8-623865D61C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528E7-FB67-4916-97F0-FA0A899F4B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808EF6-B54E-4255-BE59-D62552F3388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762120" y="380160"/>
            <a:ext cx="7086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r" pos="343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S1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Identification and validation of fourteen gene signature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,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Likelihood ratio plots for threshold selection;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ROC curve analysis; and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Boot strap valida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1523880" y="1295280"/>
            <a:ext cx="5715000" cy="481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Dr. K. Somasumdaram</dc:creator>
  <dc:description/>
  <dc:language>en-US</dc:language>
  <cp:lastModifiedBy>Glioma Lab</cp:lastModifiedBy>
  <dcterms:modified xsi:type="dcterms:W3CDTF">2013-04-05T04:45:30Z</dcterms:modified>
  <cp:revision>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